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56" r:id="rId2"/>
    <p:sldId id="257" r:id="rId3"/>
    <p:sldId id="265" r:id="rId4"/>
    <p:sldId id="258" r:id="rId5"/>
    <p:sldId id="259" r:id="rId6"/>
    <p:sldId id="260" r:id="rId7"/>
    <p:sldId id="261" r:id="rId8"/>
    <p:sldId id="264" r:id="rId9"/>
    <p:sldId id="263" r:id="rId10"/>
    <p:sldId id="266" r:id="rId11"/>
    <p:sldId id="267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69" d="100"/>
          <a:sy n="69" d="100"/>
        </p:scale>
        <p:origin x="68" y="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883B78-3279-4D8C-8C11-477FCFCB734E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B10312-5F24-492C-A410-6DCC68CAC6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75527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B10312-5F24-492C-A410-6DCC68CAC6F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3576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B10312-5F24-492C-A410-6DCC68CAC6F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40234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B10312-5F24-492C-A410-6DCC68CAC6F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46967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B10312-5F24-492C-A410-6DCC68CAC6F8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538292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B10312-5F24-492C-A410-6DCC68CAC6F8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312294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B10312-5F24-492C-A410-6DCC68CAC6F8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41846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B10312-5F24-492C-A410-6DCC68CAC6F8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9682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3F7C3-71EC-4A1D-B73E-CCF0672BB3F7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C6330-F7B0-48A2-9DE1-D0AAF4B1E8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6284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3F7C3-71EC-4A1D-B73E-CCF0672BB3F7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C6330-F7B0-48A2-9DE1-D0AAF4B1E8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44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3F7C3-71EC-4A1D-B73E-CCF0672BB3F7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C6330-F7B0-48A2-9DE1-D0AAF4B1E8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7076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3F7C3-71EC-4A1D-B73E-CCF0672BB3F7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C6330-F7B0-48A2-9DE1-D0AAF4B1E8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176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3F7C3-71EC-4A1D-B73E-CCF0672BB3F7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C6330-F7B0-48A2-9DE1-D0AAF4B1E8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57338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3F7C3-71EC-4A1D-B73E-CCF0672BB3F7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C6330-F7B0-48A2-9DE1-D0AAF4B1E8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09193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3F7C3-71EC-4A1D-B73E-CCF0672BB3F7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C6330-F7B0-48A2-9DE1-D0AAF4B1E8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1751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3F7C3-71EC-4A1D-B73E-CCF0672BB3F7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C6330-F7B0-48A2-9DE1-D0AAF4B1E8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3408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3F7C3-71EC-4A1D-B73E-CCF0672BB3F7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C6330-F7B0-48A2-9DE1-D0AAF4B1E8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30394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3F7C3-71EC-4A1D-B73E-CCF0672BB3F7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C6330-F7B0-48A2-9DE1-D0AAF4B1E8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59620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33F7C3-71EC-4A1D-B73E-CCF0672BB3F7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C6330-F7B0-48A2-9DE1-D0AAF4B1E8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9267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33F7C3-71EC-4A1D-B73E-CCF0672BB3F7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AC6330-F7B0-48A2-9DE1-D0AAF4B1E8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86619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ubtitle 2"/>
          <p:cNvSpPr>
            <a:spLocks noGrp="1"/>
          </p:cNvSpPr>
          <p:nvPr>
            <p:ph type="subTitle" idx="1"/>
          </p:nvPr>
        </p:nvSpPr>
        <p:spPr>
          <a:xfrm>
            <a:off x="0" y="0"/>
            <a:ext cx="12192000" cy="527050"/>
          </a:xfrm>
        </p:spPr>
        <p:txBody>
          <a:bodyPr>
            <a:normAutofit/>
          </a:bodyPr>
          <a:lstStyle/>
          <a:p>
            <a:r>
              <a:rPr 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a. </a:t>
            </a:r>
            <a:r>
              <a:rPr 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uve alignment of NSCV1 </a:t>
            </a:r>
            <a:r>
              <a:rPr lang="en-US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ther genomes</a:t>
            </a:r>
          </a:p>
        </p:txBody>
      </p:sp>
      <p:cxnSp>
        <p:nvCxnSpPr>
          <p:cNvPr id="7" name="Straight Connector 6"/>
          <p:cNvCxnSpPr/>
          <p:nvPr/>
        </p:nvCxnSpPr>
        <p:spPr>
          <a:xfrm>
            <a:off x="6080694" y="1150620"/>
            <a:ext cx="914400" cy="9144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" name="Group 9"/>
          <p:cNvGrpSpPr/>
          <p:nvPr/>
        </p:nvGrpSpPr>
        <p:grpSpPr>
          <a:xfrm>
            <a:off x="238535" y="660400"/>
            <a:ext cx="11684318" cy="5140115"/>
            <a:chOff x="238535" y="660400"/>
            <a:chExt cx="11684318" cy="5140115"/>
          </a:xfrm>
        </p:grpSpPr>
        <p:grpSp>
          <p:nvGrpSpPr>
            <p:cNvPr id="8" name="Group 7"/>
            <p:cNvGrpSpPr/>
            <p:nvPr/>
          </p:nvGrpSpPr>
          <p:grpSpPr>
            <a:xfrm>
              <a:off x="238535" y="992485"/>
              <a:ext cx="11684318" cy="4808030"/>
              <a:chOff x="238535" y="992485"/>
              <a:chExt cx="11684318" cy="4808030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8535" y="992485"/>
                <a:ext cx="11684318" cy="4808030"/>
              </a:xfrm>
              <a:prstGeom prst="rect">
                <a:avLst/>
              </a:prstGeom>
            </p:spPr>
          </p:pic>
          <p:cxnSp>
            <p:nvCxnSpPr>
              <p:cNvPr id="3" name="Straight Connector 2"/>
              <p:cNvCxnSpPr/>
              <p:nvPr/>
            </p:nvCxnSpPr>
            <p:spPr>
              <a:xfrm>
                <a:off x="5227320" y="1150620"/>
                <a:ext cx="2926080" cy="15240"/>
              </a:xfrm>
              <a:prstGeom prst="line">
                <a:avLst/>
              </a:prstGeom>
              <a:ln w="3492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" name="TextBox 8"/>
            <p:cNvSpPr txBox="1"/>
            <p:nvPr/>
          </p:nvSpPr>
          <p:spPr>
            <a:xfrm>
              <a:off x="6350000" y="660400"/>
              <a:ext cx="6985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r</a:t>
              </a:r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100109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ubtitle 2"/>
          <p:cNvSpPr txBox="1">
            <a:spLocks/>
          </p:cNvSpPr>
          <p:nvPr/>
        </p:nvSpPr>
        <p:spPr>
          <a:xfrm>
            <a:off x="0" y="0"/>
            <a:ext cx="12192000" cy="5270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. ACT view of NSCV1 Chr1 and Chr2 fusion junction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1302" y="577512"/>
            <a:ext cx="8229600" cy="6172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3009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ubtitle 2"/>
          <p:cNvSpPr txBox="1">
            <a:spLocks/>
          </p:cNvSpPr>
          <p:nvPr/>
        </p:nvSpPr>
        <p:spPr>
          <a:xfrm>
            <a:off x="0" y="0"/>
            <a:ext cx="12192000" cy="5270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9. ACT view of NSCV2 Chr1 and Chr2 fusion junction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2966" y="577512"/>
            <a:ext cx="8229600" cy="6172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31738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ubtitle 2"/>
          <p:cNvSpPr txBox="1">
            <a:spLocks/>
          </p:cNvSpPr>
          <p:nvPr/>
        </p:nvSpPr>
        <p:spPr>
          <a:xfrm>
            <a:off x="0" y="0"/>
            <a:ext cx="12192000" cy="5270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b. Mauve alignment of NSCV2 with other genomes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347658" y="482600"/>
            <a:ext cx="11496675" cy="5803899"/>
            <a:chOff x="347658" y="368300"/>
            <a:chExt cx="11496675" cy="5803899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7658" y="685799"/>
              <a:ext cx="11496675" cy="5486400"/>
            </a:xfrm>
            <a:prstGeom prst="rect">
              <a:avLst/>
            </a:prstGeom>
          </p:spPr>
        </p:pic>
        <p:cxnSp>
          <p:nvCxnSpPr>
            <p:cNvPr id="4" name="Straight Connector 3"/>
            <p:cNvCxnSpPr/>
            <p:nvPr/>
          </p:nvCxnSpPr>
          <p:spPr>
            <a:xfrm>
              <a:off x="1341120" y="861839"/>
              <a:ext cx="2926080" cy="8603"/>
            </a:xfrm>
            <a:prstGeom prst="line">
              <a:avLst/>
            </a:prstGeom>
            <a:ln w="3492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6"/>
            <p:cNvSpPr txBox="1"/>
            <p:nvPr/>
          </p:nvSpPr>
          <p:spPr>
            <a:xfrm>
              <a:off x="2501900" y="368300"/>
              <a:ext cx="6985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r</a:t>
              </a:r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676758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ubtitle 2"/>
          <p:cNvSpPr txBox="1">
            <a:spLocks/>
          </p:cNvSpPr>
          <p:nvPr/>
        </p:nvSpPr>
        <p:spPr>
          <a:xfrm>
            <a:off x="0" y="0"/>
            <a:ext cx="12192000" cy="527050"/>
          </a:xfrm>
          <a:prstGeom prst="rect">
            <a:avLst/>
          </a:prstGeom>
        </p:spPr>
        <p:txBody>
          <a:bodyPr vert="horz" lIns="91440" tIns="45720" rIns="91440" bIns="45720" rtlCol="0">
            <a:normAutofit fontScale="85000" lnSpcReduction="1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IG view of genomic comparisons of NSCV1, NSCV2, N16961, TSY216 and MS6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35" b="17728"/>
          <a:stretch/>
        </p:blipFill>
        <p:spPr>
          <a:xfrm>
            <a:off x="315683" y="1722458"/>
            <a:ext cx="3644273" cy="338532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76" b="22175"/>
          <a:stretch/>
        </p:blipFill>
        <p:spPr>
          <a:xfrm>
            <a:off x="4264998" y="1764638"/>
            <a:ext cx="3759635" cy="3200402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48" b="18363"/>
          <a:stretch/>
        </p:blipFill>
        <p:spPr>
          <a:xfrm>
            <a:off x="7997763" y="1731977"/>
            <a:ext cx="3764899" cy="33571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36989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ubtitle 2"/>
          <p:cNvSpPr txBox="1">
            <a:spLocks/>
          </p:cNvSpPr>
          <p:nvPr/>
        </p:nvSpPr>
        <p:spPr>
          <a:xfrm>
            <a:off x="0" y="0"/>
            <a:ext cx="12192000" cy="5270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a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rcular maps of NSCV1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ing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ious features</a:t>
            </a:r>
          </a:p>
          <a:p>
            <a:pPr marL="0" indent="0">
              <a:buNone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2736759" y="527050"/>
            <a:ext cx="6718481" cy="6059166"/>
            <a:chOff x="2736759" y="527050"/>
            <a:chExt cx="6718481" cy="6059166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/>
            <a:srcRect l="2448" t="2181" r="2448" b="12048"/>
            <a:stretch/>
          </p:blipFill>
          <p:spPr>
            <a:xfrm>
              <a:off x="2736759" y="527050"/>
              <a:ext cx="6718481" cy="6059166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/>
          </p:nvSpPr>
          <p:spPr>
            <a:xfrm>
              <a:off x="5483439" y="3371967"/>
              <a:ext cx="122511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CV1</a:t>
              </a:r>
              <a:endParaRPr 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331387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ubtitle 2"/>
          <p:cNvSpPr txBox="1">
            <a:spLocks/>
          </p:cNvSpPr>
          <p:nvPr/>
        </p:nvSpPr>
        <p:spPr>
          <a:xfrm>
            <a:off x="0" y="0"/>
            <a:ext cx="12192000" cy="5270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b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rcular maps of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SCV2 showing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ious features</a:t>
            </a:r>
          </a:p>
          <a:p>
            <a:pPr marL="0" indent="0" algn="ctr">
              <a:buNone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2782236" y="527050"/>
            <a:ext cx="6627528" cy="6072538"/>
            <a:chOff x="2782236" y="527050"/>
            <a:chExt cx="6627528" cy="6072538"/>
          </a:xfrm>
        </p:grpSpPr>
        <p:pic>
          <p:nvPicPr>
            <p:cNvPr id="5" name="Picture 4" descr="vab_dnaplotter.png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62" t="2148" r="3094" b="11500"/>
            <a:stretch/>
          </p:blipFill>
          <p:spPr>
            <a:xfrm>
              <a:off x="2782236" y="527050"/>
              <a:ext cx="6627528" cy="6072538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5483440" y="3378653"/>
              <a:ext cx="122511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CV2</a:t>
              </a:r>
              <a:endParaRPr 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589634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ubtitle 2"/>
          <p:cNvSpPr txBox="1">
            <a:spLocks/>
          </p:cNvSpPr>
          <p:nvPr/>
        </p:nvSpPr>
        <p:spPr>
          <a:xfrm>
            <a:off x="0" y="0"/>
            <a:ext cx="12192000" cy="5270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GM maps compared to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lico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rated restriction maps of WGS</a:t>
            </a:r>
          </a:p>
          <a:p>
            <a:pPr marL="0" indent="0">
              <a:buNone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150796" y="901497"/>
            <a:ext cx="11922533" cy="4196362"/>
            <a:chOff x="150796" y="901497"/>
            <a:chExt cx="11922533" cy="4196362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0796" y="1258367"/>
              <a:ext cx="11887200" cy="142875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6129" y="3154759"/>
              <a:ext cx="11887200" cy="194310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150796" y="901497"/>
              <a:ext cx="132884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CV1</a:t>
              </a:r>
              <a:endPara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66036" y="2852217"/>
              <a:ext cx="132884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CV2</a:t>
              </a:r>
              <a:endPara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005851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ubtitle 2"/>
          <p:cNvSpPr txBox="1">
            <a:spLocks/>
          </p:cNvSpPr>
          <p:nvPr/>
        </p:nvSpPr>
        <p:spPr>
          <a:xfrm>
            <a:off x="0" y="0"/>
            <a:ext cx="12192000" cy="5270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e coverage at tandem repeats of NSCV1 and NSCV2</a:t>
            </a:r>
          </a:p>
          <a:p>
            <a:pPr marL="0" indent="0" algn="ctr">
              <a:buNone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7" name="Group 16"/>
          <p:cNvGrpSpPr/>
          <p:nvPr/>
        </p:nvGrpSpPr>
        <p:grpSpPr>
          <a:xfrm>
            <a:off x="1469295" y="538479"/>
            <a:ext cx="7021022" cy="6341556"/>
            <a:chOff x="1469295" y="538479"/>
            <a:chExt cx="7021022" cy="6341556"/>
          </a:xfrm>
        </p:grpSpPr>
        <p:pic>
          <p:nvPicPr>
            <p:cNvPr id="7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633100" y="3742690"/>
              <a:ext cx="5791391" cy="313734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9" name="Picture 3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2616059" y="538479"/>
              <a:ext cx="5874258" cy="32689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4" name="Group 3"/>
            <p:cNvGrpSpPr/>
            <p:nvPr/>
          </p:nvGrpSpPr>
          <p:grpSpPr>
            <a:xfrm>
              <a:off x="1469295" y="1849885"/>
              <a:ext cx="1225119" cy="3579984"/>
              <a:chOff x="1469295" y="1849885"/>
              <a:chExt cx="1225119" cy="3579984"/>
            </a:xfrm>
          </p:grpSpPr>
          <p:sp>
            <p:nvSpPr>
              <p:cNvPr id="12" name="TextBox 11"/>
              <p:cNvSpPr txBox="1"/>
              <p:nvPr/>
            </p:nvSpPr>
            <p:spPr>
              <a:xfrm>
                <a:off x="1469295" y="1849885"/>
                <a:ext cx="122511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CV1</a:t>
                </a:r>
                <a:endPara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1469295" y="5060537"/>
                <a:ext cx="122511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CV2</a:t>
                </a:r>
                <a:endPara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3" name="Group 2"/>
          <p:cNvGrpSpPr/>
          <p:nvPr/>
        </p:nvGrpSpPr>
        <p:grpSpPr>
          <a:xfrm>
            <a:off x="5011699" y="820249"/>
            <a:ext cx="213348" cy="4658366"/>
            <a:chOff x="5011699" y="820249"/>
            <a:chExt cx="213348" cy="4658366"/>
          </a:xfrm>
        </p:grpSpPr>
        <p:sp>
          <p:nvSpPr>
            <p:cNvPr id="2" name="5-Point Star 1"/>
            <p:cNvSpPr>
              <a:spLocks noChangeAspect="1"/>
            </p:cNvSpPr>
            <p:nvPr/>
          </p:nvSpPr>
          <p:spPr>
            <a:xfrm>
              <a:off x="5020164" y="820249"/>
              <a:ext cx="179485" cy="179485"/>
            </a:xfrm>
            <a:prstGeom prst="star5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5-Point Star 13"/>
            <p:cNvSpPr>
              <a:spLocks noChangeAspect="1"/>
            </p:cNvSpPr>
            <p:nvPr/>
          </p:nvSpPr>
          <p:spPr>
            <a:xfrm>
              <a:off x="5045562" y="5299130"/>
              <a:ext cx="179485" cy="179485"/>
            </a:xfrm>
            <a:prstGeom prst="star5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5-Point Star 14"/>
            <p:cNvSpPr>
              <a:spLocks noChangeAspect="1"/>
            </p:cNvSpPr>
            <p:nvPr/>
          </p:nvSpPr>
          <p:spPr>
            <a:xfrm>
              <a:off x="5045561" y="4215397"/>
              <a:ext cx="179485" cy="179485"/>
            </a:xfrm>
            <a:prstGeom prst="star5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5-Point Star 15"/>
            <p:cNvSpPr>
              <a:spLocks noChangeAspect="1"/>
            </p:cNvSpPr>
            <p:nvPr/>
          </p:nvSpPr>
          <p:spPr>
            <a:xfrm>
              <a:off x="5011699" y="2225715"/>
              <a:ext cx="179485" cy="179485"/>
            </a:xfrm>
            <a:prstGeom prst="star5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40107502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ubtitle 2"/>
          <p:cNvSpPr txBox="1">
            <a:spLocks/>
          </p:cNvSpPr>
          <p:nvPr/>
        </p:nvSpPr>
        <p:spPr>
          <a:xfrm>
            <a:off x="0" y="0"/>
            <a:ext cx="12192000" cy="5270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ps of NSCV1 and NSCV2 with tandem repeats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227948" y="880139"/>
            <a:ext cx="11638481" cy="6168460"/>
            <a:chOff x="227948" y="880139"/>
            <a:chExt cx="11638481" cy="6168460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7948" y="880139"/>
              <a:ext cx="6127312" cy="616846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90489" y="880139"/>
              <a:ext cx="6175940" cy="616846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457200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ubtitle 2"/>
          <p:cNvSpPr txBox="1">
            <a:spLocks/>
          </p:cNvSpPr>
          <p:nvPr/>
        </p:nvSpPr>
        <p:spPr>
          <a:xfrm>
            <a:off x="0" y="0"/>
            <a:ext cx="12192000" cy="5270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lap of repeat regions in NSCV1 and NSCV2</a:t>
            </a:r>
          </a:p>
          <a:p>
            <a:pPr marL="0" indent="0" algn="ctr">
              <a:buNone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34528" y="1408218"/>
            <a:ext cx="9219047" cy="4609524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601133" y="1408218"/>
            <a:ext cx="553998" cy="46095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SCV2 tandem repeat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134528" y="6121400"/>
            <a:ext cx="91440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SCV1 tandem repeat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9544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0</TotalTime>
  <Words>152</Words>
  <Application>Microsoft Office PowerPoint</Application>
  <PresentationFormat>Widescreen</PresentationFormat>
  <Paragraphs>28</Paragraphs>
  <Slides>11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ted States Arm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nmuga.Sozhamannan</dc:creator>
  <cp:lastModifiedBy>Sozhamannan, Shanmuga Dr.</cp:lastModifiedBy>
  <cp:revision>22</cp:revision>
  <dcterms:created xsi:type="dcterms:W3CDTF">2017-02-15T02:56:08Z</dcterms:created>
  <dcterms:modified xsi:type="dcterms:W3CDTF">2017-06-22T15:20:54Z</dcterms:modified>
</cp:coreProperties>
</file>